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7"/>
  </p:notesMasterIdLst>
  <p:sldIdLst>
    <p:sldId id="261" r:id="rId2"/>
    <p:sldId id="10705784" r:id="rId3"/>
    <p:sldId id="10705785" r:id="rId4"/>
    <p:sldId id="10705786" r:id="rId5"/>
    <p:sldId id="10705787" r:id="rId6"/>
    <p:sldId id="10705791" r:id="rId7"/>
    <p:sldId id="10705792" r:id="rId8"/>
    <p:sldId id="464" r:id="rId9"/>
    <p:sldId id="10705748" r:id="rId10"/>
    <p:sldId id="10705766" r:id="rId11"/>
    <p:sldId id="10705733" r:id="rId12"/>
    <p:sldId id="467" r:id="rId13"/>
    <p:sldId id="10705770" r:id="rId14"/>
    <p:sldId id="10705783" r:id="rId15"/>
    <p:sldId id="10705779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19CFF"/>
    <a:srgbClr val="00BA38"/>
    <a:srgbClr val="F8766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791" autoAdjust="0"/>
    <p:restoredTop sz="94660"/>
  </p:normalViewPr>
  <p:slideViewPr>
    <p:cSldViewPr snapToGrid="0">
      <p:cViewPr varScale="1">
        <p:scale>
          <a:sx n="84" d="100"/>
          <a:sy n="84" d="100"/>
        </p:scale>
        <p:origin x="5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-4155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Relationship Id="rId4" Type="http://schemas.openxmlformats.org/officeDocument/2006/relationships/image" Target="../media/image28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7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image" Target="../media/image10.emf"/></Relationships>
</file>

<file path=ppt/drawings/_rels/vmlDrawing9.v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013EC9-BE80-412F-AFB6-96BE071FB216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4C3E1F-841B-4FAF-AAB9-8D96508756EC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6E6237-0046-4057-AE31-B7EC89F9A50A}" type="datetimeFigureOut">
              <a:rPr lang="en-US" smtClean="0"/>
              <a:t>2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F3EC0D-4FFA-46BC-9C17-7E33851F8547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11.e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10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23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22.em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26.emf"/><Relationship Id="rId5" Type="http://schemas.openxmlformats.org/officeDocument/2006/relationships/oleObject" Target="../embeddings/oleObject16.bin"/><Relationship Id="rId10" Type="http://schemas.openxmlformats.org/officeDocument/2006/relationships/image" Target="../media/image28.emf"/><Relationship Id="rId4" Type="http://schemas.openxmlformats.org/officeDocument/2006/relationships/image" Target="../media/image25.emf"/><Relationship Id="rId9" Type="http://schemas.openxmlformats.org/officeDocument/2006/relationships/oleObject" Target="../embeddings/oleObject18.bin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D59FD494-2F19-40F7-8CC2-6CDED405B0A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3964285"/>
              </p:ext>
            </p:extLst>
          </p:nvPr>
        </p:nvGraphicFramePr>
        <p:xfrm>
          <a:off x="4183063" y="1263650"/>
          <a:ext cx="4068762" cy="3592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0" name="Prism 9" r:id="rId3" imgW="4068563" imgH="3593137" progId="Prism9.Document">
                  <p:embed/>
                </p:oleObj>
              </mc:Choice>
              <mc:Fallback>
                <p:oleObj name="Prism 9" r:id="rId3" imgW="4068563" imgH="359313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83063" y="1263650"/>
                        <a:ext cx="4068762" cy="3592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0" y="6519446"/>
            <a:ext cx="97156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. Narazaciclib’s inhibitory potency against kinases CSF1R, FLT3 and CDK6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8A471AB-55A7-40FE-956C-A7F8106DF3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8936192"/>
              </p:ext>
            </p:extLst>
          </p:nvPr>
        </p:nvGraphicFramePr>
        <p:xfrm>
          <a:off x="98259" y="1263386"/>
          <a:ext cx="4068763" cy="3548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1" name="Prism 9" r:id="rId5" imgW="4068563" imgH="3547422" progId="Prism9.Document">
                  <p:embed/>
                </p:oleObj>
              </mc:Choice>
              <mc:Fallback>
                <p:oleObj name="Prism 9" r:id="rId5" imgW="4068563" imgH="35474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8259" y="1263386"/>
                        <a:ext cx="4068763" cy="3548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2CD38F0-388E-4F3B-B88B-BFFBA155EA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8673691"/>
              </p:ext>
            </p:extLst>
          </p:nvPr>
        </p:nvGraphicFramePr>
        <p:xfrm>
          <a:off x="8241703" y="1263386"/>
          <a:ext cx="4060825" cy="3548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02" name="Prism 9" r:id="rId7" imgW="4061004" imgH="3547422" progId="Prism9.Document">
                  <p:embed/>
                </p:oleObj>
              </mc:Choice>
              <mc:Fallback>
                <p:oleObj name="Prism 9" r:id="rId7" imgW="4061004" imgH="354742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241703" y="1263386"/>
                        <a:ext cx="4060825" cy="3548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08EFBDFE-6022-464E-B3FD-1C90A7FF5858}"/>
              </a:ext>
            </a:extLst>
          </p:cNvPr>
          <p:cNvSpPr txBox="1"/>
          <p:nvPr/>
        </p:nvSpPr>
        <p:spPr>
          <a:xfrm>
            <a:off x="98259" y="12633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BA9CDB6-0202-4284-8535-C59691C0C8BF}"/>
              </a:ext>
            </a:extLst>
          </p:cNvPr>
          <p:cNvSpPr txBox="1"/>
          <p:nvPr/>
        </p:nvSpPr>
        <p:spPr>
          <a:xfrm>
            <a:off x="4164483" y="12633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D5633C0-D0F0-40A2-BC5B-5D7ABD7BFF37}"/>
              </a:ext>
            </a:extLst>
          </p:cNvPr>
          <p:cNvSpPr txBox="1"/>
          <p:nvPr/>
        </p:nvSpPr>
        <p:spPr>
          <a:xfrm>
            <a:off x="8121151" y="12633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9337" y="52707"/>
            <a:ext cx="4033769" cy="21337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11804" y="153381"/>
            <a:ext cx="3653956" cy="19328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850" y="64829"/>
            <a:ext cx="3974176" cy="21100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0" y="6514902"/>
            <a:ext cx="109503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. Representative proliferation inhibition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urves of narazaciclib in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AML cell lines 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in vitro.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-214748257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5735" y="2364740"/>
            <a:ext cx="3752850" cy="198564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" name="图片 -214748256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40200" y="2364740"/>
            <a:ext cx="3753485" cy="198628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" name="图片 -214748255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11515" y="2364740"/>
            <a:ext cx="3752850" cy="198564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" name="图片 -214748257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79240" y="4351020"/>
            <a:ext cx="3975735" cy="2103755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01FABF3-6AE4-4389-B02D-CF67371716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87" y="1490864"/>
            <a:ext cx="5162641" cy="3420000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8D245669-D959-45EF-8E36-9ED5B87247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737" y="6167941"/>
            <a:ext cx="12070525" cy="584988"/>
          </a:xfrm>
        </p:spPr>
        <p:txBody>
          <a:bodyPr>
            <a:no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. Growth inhibition readouts AUC vs. IC</a:t>
            </a:r>
            <a:r>
              <a: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: Definitions of AUC and IC</a:t>
            </a:r>
            <a:r>
              <a:rPr lang="en-US" sz="16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of proliferation inhibition. B: Extremely high concordance (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ositive correlation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between AUC and IC</a:t>
            </a:r>
            <a:r>
              <a:rPr lang="en-US" sz="16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across 33 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ML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ell lines.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8E9451C9-A9AC-4ECD-95DA-8C81ADAF6CE5}"/>
              </a:ext>
            </a:extLst>
          </p:cNvPr>
          <p:cNvGrpSpPr/>
          <p:nvPr/>
        </p:nvGrpSpPr>
        <p:grpSpPr>
          <a:xfrm>
            <a:off x="5052789" y="900947"/>
            <a:ext cx="6153691" cy="5056686"/>
            <a:chOff x="5052789" y="900947"/>
            <a:chExt cx="6153691" cy="5056686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D2C613DE-091E-4634-AE50-031FF7173F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826" t="1169" r="13290" b="6093"/>
            <a:stretch/>
          </p:blipFill>
          <p:spPr>
            <a:xfrm>
              <a:off x="5820288" y="916568"/>
              <a:ext cx="5369926" cy="4406967"/>
            </a:xfrm>
            <a:prstGeom prst="rect">
              <a:avLst/>
            </a:prstGeom>
          </p:spPr>
        </p:pic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F28B791B-37D5-4988-8DB0-9438B6C90E1A}"/>
                </a:ext>
              </a:extLst>
            </p:cNvPr>
            <p:cNvGrpSpPr/>
            <p:nvPr/>
          </p:nvGrpSpPr>
          <p:grpSpPr>
            <a:xfrm>
              <a:off x="5052789" y="900947"/>
              <a:ext cx="6153691" cy="5056686"/>
              <a:chOff x="4547824" y="773456"/>
              <a:chExt cx="6153691" cy="5056686"/>
            </a:xfrm>
          </p:grpSpPr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3220EBCE-E5FE-4FED-A8A2-4C1D5DFF1DA8}"/>
                  </a:ext>
                </a:extLst>
              </p:cNvPr>
              <p:cNvSpPr txBox="1"/>
              <p:nvPr/>
            </p:nvSpPr>
            <p:spPr>
              <a:xfrm>
                <a:off x="5314797" y="776885"/>
                <a:ext cx="3376246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ensitive:</a:t>
                </a:r>
                <a:r>
                  <a:rPr lang="zh-CN" alt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UC &lt; 2.4</a:t>
                </a: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ntermediate: 2.8 ≥ AUC ≥ 2.4</a:t>
                </a:r>
              </a:p>
              <a:p>
                <a:pPr marL="285750" indent="-285750">
                  <a:buFont typeface="Arial" panose="020B0604020202020204" pitchFamily="34" charset="0"/>
                  <a:buChar char="•"/>
                </a:pPr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nsensitive: AUC ≥ 2.8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0E0FBB81-70B4-4568-83C5-506B1DBB097F}"/>
                  </a:ext>
                </a:extLst>
              </p:cNvPr>
              <p:cNvSpPr txBox="1"/>
              <p:nvPr/>
            </p:nvSpPr>
            <p:spPr>
              <a:xfrm>
                <a:off x="6377039" y="1515034"/>
                <a:ext cx="3376246" cy="307777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 = 0.943, p &lt; 0.001</a:t>
                </a:r>
              </a:p>
            </p:txBody>
          </p: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53B99E3C-6F78-49F1-A066-E700583B911A}"/>
                  </a:ext>
                </a:extLst>
              </p:cNvPr>
              <p:cNvCxnSpPr/>
              <p:nvPr/>
            </p:nvCxnSpPr>
            <p:spPr>
              <a:xfrm>
                <a:off x="5231716" y="1863592"/>
                <a:ext cx="803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94BB457E-9236-47F8-90DD-C36CED8A00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14008" y="773456"/>
                <a:ext cx="0" cy="443211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2EB8DB32-3660-4065-B94E-8B1FEB91C586}"/>
                  </a:ext>
                </a:extLst>
              </p:cNvPr>
              <p:cNvCxnSpPr/>
              <p:nvPr/>
            </p:nvCxnSpPr>
            <p:spPr>
              <a:xfrm>
                <a:off x="5235526" y="2986272"/>
                <a:ext cx="803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1ABDC142-279E-4750-BFCF-11C7980F1C59}"/>
                  </a:ext>
                </a:extLst>
              </p:cNvPr>
              <p:cNvCxnSpPr/>
              <p:nvPr/>
            </p:nvCxnSpPr>
            <p:spPr>
              <a:xfrm>
                <a:off x="5239336" y="4112762"/>
                <a:ext cx="803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7CDA2CD6-0041-45F3-9245-87A4010385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03848" y="5205570"/>
                <a:ext cx="5397667" cy="9525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C8E8715D-5F63-42B8-B848-4CFA3F99273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203266" y="5245764"/>
                <a:ext cx="803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94CD53C5-14A3-4477-9018-11FF6A87F0E7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7881571" y="5245765"/>
                <a:ext cx="803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id="{D4CC6EC3-3A81-4718-B212-1A134EF6FAD2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9567496" y="5255290"/>
                <a:ext cx="8038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id="{97A52476-F2FF-4398-8106-A777615DB8EB}"/>
                  </a:ext>
                </a:extLst>
              </p:cNvPr>
              <p:cNvCxnSpPr/>
              <p:nvPr/>
            </p:nvCxnSpPr>
            <p:spPr>
              <a:xfrm>
                <a:off x="10692384" y="773456"/>
                <a:ext cx="0" cy="443821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5AE97D77-A38A-460D-863E-3BD7ACC136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07912" y="782981"/>
                <a:ext cx="539360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EF7CA8B8-32F9-445A-9FCE-388CFED10F50}"/>
                  </a:ext>
                </a:extLst>
              </p:cNvPr>
              <p:cNvSpPr txBox="1"/>
              <p:nvPr/>
            </p:nvSpPr>
            <p:spPr>
              <a:xfrm>
                <a:off x="4668363" y="3955977"/>
                <a:ext cx="639697" cy="30765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1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7A3CF00-A17D-4291-BB83-C237964A2684}"/>
                  </a:ext>
                </a:extLst>
              </p:cNvPr>
              <p:cNvSpPr txBox="1"/>
              <p:nvPr/>
            </p:nvSpPr>
            <p:spPr>
              <a:xfrm>
                <a:off x="4810486" y="2835684"/>
                <a:ext cx="470174" cy="30765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92C06175-0A76-44EC-B63A-6193B0F836C9}"/>
                  </a:ext>
                </a:extLst>
              </p:cNvPr>
              <p:cNvSpPr txBox="1"/>
              <p:nvPr/>
            </p:nvSpPr>
            <p:spPr>
              <a:xfrm>
                <a:off x="4561796" y="1695547"/>
                <a:ext cx="666700" cy="316046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CB9D712D-0525-4A26-9AD0-48C11A89BD6B}"/>
                  </a:ext>
                </a:extLst>
              </p:cNvPr>
              <p:cNvSpPr txBox="1"/>
              <p:nvPr/>
            </p:nvSpPr>
            <p:spPr>
              <a:xfrm>
                <a:off x="6087019" y="5278036"/>
                <a:ext cx="290020" cy="307776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3356ABA-45B6-44D1-B147-156ED5CAB99D}"/>
                  </a:ext>
                </a:extLst>
              </p:cNvPr>
              <p:cNvSpPr txBox="1"/>
              <p:nvPr/>
            </p:nvSpPr>
            <p:spPr>
              <a:xfrm>
                <a:off x="7780563" y="5249571"/>
                <a:ext cx="290020" cy="307776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74D0430-9351-4645-8324-45ABFCB264A4}"/>
                  </a:ext>
                </a:extLst>
              </p:cNvPr>
              <p:cNvSpPr txBox="1"/>
              <p:nvPr/>
            </p:nvSpPr>
            <p:spPr>
              <a:xfrm>
                <a:off x="9470297" y="5249571"/>
                <a:ext cx="290020" cy="307776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0AD9D05E-211D-454E-B8EE-A45213F9E4BE}"/>
                  </a:ext>
                </a:extLst>
              </p:cNvPr>
              <p:cNvSpPr txBox="1"/>
              <p:nvPr/>
            </p:nvSpPr>
            <p:spPr>
              <a:xfrm>
                <a:off x="7251741" y="5522366"/>
                <a:ext cx="1340045" cy="307776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UC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76FD48A2-D976-4BC2-A0B9-20E9021136C9}"/>
                  </a:ext>
                </a:extLst>
              </p:cNvPr>
              <p:cNvSpPr txBox="1"/>
              <p:nvPr/>
            </p:nvSpPr>
            <p:spPr>
              <a:xfrm rot="16200000">
                <a:off x="4031689" y="2835624"/>
                <a:ext cx="1340045" cy="307776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C</a:t>
                </a:r>
                <a:r>
                  <a:rPr lang="en-US" altLang="zh-CN" sz="14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µM)</a:t>
                </a:r>
              </a:p>
            </p:txBody>
          </p:sp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D121ED5E-F775-4F20-A76E-44FADAD86A14}"/>
                  </a:ext>
                </a:extLst>
              </p:cNvPr>
              <p:cNvGrpSpPr/>
              <p:nvPr/>
            </p:nvGrpSpPr>
            <p:grpSpPr>
              <a:xfrm>
                <a:off x="9275182" y="4189883"/>
                <a:ext cx="1406717" cy="960204"/>
                <a:chOff x="8169084" y="4020422"/>
                <a:chExt cx="1406717" cy="960204"/>
              </a:xfrm>
            </p:grpSpPr>
            <p:sp>
              <p:nvSpPr>
                <p:cNvPr id="30" name="Oval 29">
                  <a:extLst>
                    <a:ext uri="{FF2B5EF4-FFF2-40B4-BE49-F238E27FC236}">
                      <a16:creationId xmlns:a16="http://schemas.microsoft.com/office/drawing/2014/main" id="{9AB0B68C-2548-4161-AE0B-E90482570B0D}"/>
                    </a:ext>
                  </a:extLst>
                </p:cNvPr>
                <p:cNvSpPr/>
                <p:nvPr/>
              </p:nvSpPr>
              <p:spPr>
                <a:xfrm>
                  <a:off x="8169084" y="4094174"/>
                  <a:ext cx="157798" cy="162560"/>
                </a:xfrm>
                <a:prstGeom prst="ellipse">
                  <a:avLst/>
                </a:prstGeom>
                <a:solidFill>
                  <a:srgbClr val="F8766D"/>
                </a:solidFill>
                <a:ln>
                  <a:solidFill>
                    <a:srgbClr val="F8766D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1" name="Oval 30">
                  <a:extLst>
                    <a:ext uri="{FF2B5EF4-FFF2-40B4-BE49-F238E27FC236}">
                      <a16:creationId xmlns:a16="http://schemas.microsoft.com/office/drawing/2014/main" id="{4EA7C84B-5E63-48C8-B177-AE6C79F17173}"/>
                    </a:ext>
                  </a:extLst>
                </p:cNvPr>
                <p:cNvSpPr/>
                <p:nvPr/>
              </p:nvSpPr>
              <p:spPr>
                <a:xfrm>
                  <a:off x="8169084" y="4419244"/>
                  <a:ext cx="157798" cy="162560"/>
                </a:xfrm>
                <a:prstGeom prst="ellipse">
                  <a:avLst/>
                </a:prstGeom>
                <a:solidFill>
                  <a:srgbClr val="00BA38"/>
                </a:solidFill>
                <a:ln>
                  <a:solidFill>
                    <a:srgbClr val="00BA38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2" name="Oval 31">
                  <a:extLst>
                    <a:ext uri="{FF2B5EF4-FFF2-40B4-BE49-F238E27FC236}">
                      <a16:creationId xmlns:a16="http://schemas.microsoft.com/office/drawing/2014/main" id="{20910521-ECE9-42F6-904B-A1FC83D800D7}"/>
                    </a:ext>
                  </a:extLst>
                </p:cNvPr>
                <p:cNvSpPr/>
                <p:nvPr/>
              </p:nvSpPr>
              <p:spPr>
                <a:xfrm>
                  <a:off x="8169084" y="4744314"/>
                  <a:ext cx="157798" cy="162560"/>
                </a:xfrm>
                <a:prstGeom prst="ellipse">
                  <a:avLst/>
                </a:prstGeom>
                <a:solidFill>
                  <a:srgbClr val="619CFF"/>
                </a:solidFill>
                <a:ln>
                  <a:solidFill>
                    <a:srgbClr val="619C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D0C99FFE-099D-41AD-B8BB-FC56CA20D481}"/>
                    </a:ext>
                  </a:extLst>
                </p:cNvPr>
                <p:cNvSpPr txBox="1"/>
                <p:nvPr/>
              </p:nvSpPr>
              <p:spPr>
                <a:xfrm>
                  <a:off x="8326883" y="4020422"/>
                  <a:ext cx="1248918" cy="30777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altLang="zh-CN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ensitive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F02324A6-37F2-4B60-96AF-0EBD787D9E3B}"/>
                    </a:ext>
                  </a:extLst>
                </p:cNvPr>
                <p:cNvSpPr txBox="1"/>
                <p:nvPr/>
              </p:nvSpPr>
              <p:spPr>
                <a:xfrm>
                  <a:off x="8326883" y="4349192"/>
                  <a:ext cx="1248918" cy="30777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altLang="zh-CN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termediate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40CBB0A1-BBF0-4D99-B504-C08344249973}"/>
                    </a:ext>
                  </a:extLst>
                </p:cNvPr>
                <p:cNvSpPr txBox="1"/>
                <p:nvPr/>
              </p:nvSpPr>
              <p:spPr>
                <a:xfrm>
                  <a:off x="8326882" y="4672849"/>
                  <a:ext cx="1248919" cy="307777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r>
                    <a:rPr lang="en-US" altLang="zh-CN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sensitive</a:t>
                  </a:r>
                </a:p>
              </p:txBody>
            </p:sp>
          </p:grpSp>
        </p:grp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12649C2A-20F5-427D-9DBC-AEAF2F6DCC8B}"/>
              </a:ext>
            </a:extLst>
          </p:cNvPr>
          <p:cNvSpPr txBox="1"/>
          <p:nvPr/>
        </p:nvSpPr>
        <p:spPr>
          <a:xfrm>
            <a:off x="98259" y="12633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0AB1D58-37D2-4B1D-9BE7-15E7D4FF9AF2}"/>
              </a:ext>
            </a:extLst>
          </p:cNvPr>
          <p:cNvSpPr txBox="1"/>
          <p:nvPr/>
        </p:nvSpPr>
        <p:spPr>
          <a:xfrm>
            <a:off x="5076379" y="54114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46436083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6519446"/>
            <a:ext cx="122811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6. AM8096 does not respond to AC220 (</a:t>
            </a:r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quizartinib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eukemic loads in different organs at the termination. 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099D7D5A-3C60-4A2E-8DD7-3748172F05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2438867"/>
              </p:ext>
            </p:extLst>
          </p:nvPr>
        </p:nvGraphicFramePr>
        <p:xfrm>
          <a:off x="1732789" y="1659146"/>
          <a:ext cx="3057525" cy="2814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1" name="Prism 9" r:id="rId3" imgW="3056732" imgH="2814540" progId="Prism9.Document">
                  <p:embed/>
                </p:oleObj>
              </mc:Choice>
              <mc:Fallback>
                <p:oleObj name="Prism 9" r:id="rId3" imgW="3056732" imgH="28145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32789" y="1659146"/>
                        <a:ext cx="3057525" cy="2814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71098BA3-85E0-423B-AD73-CF99BD7219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2650189"/>
              </p:ext>
            </p:extLst>
          </p:nvPr>
        </p:nvGraphicFramePr>
        <p:xfrm>
          <a:off x="4790314" y="1659147"/>
          <a:ext cx="3155950" cy="2814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2" name="Prism 9" r:id="rId5" imgW="3155719" imgH="2814540" progId="Prism9.Document">
                  <p:embed/>
                </p:oleObj>
              </mc:Choice>
              <mc:Fallback>
                <p:oleObj name="Prism 9" r:id="rId5" imgW="3155719" imgH="28145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90314" y="1659147"/>
                        <a:ext cx="3155950" cy="2814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F6F4B166-1F25-48DB-81D8-723DA2BC2D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4944811"/>
              </p:ext>
            </p:extLst>
          </p:nvPr>
        </p:nvGraphicFramePr>
        <p:xfrm>
          <a:off x="7946264" y="1659146"/>
          <a:ext cx="3057525" cy="2814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3" name="Prism 9" r:id="rId7" imgW="3056732" imgH="2814540" progId="Prism9.Document">
                  <p:embed/>
                </p:oleObj>
              </mc:Choice>
              <mc:Fallback>
                <p:oleObj name="Prism 9" r:id="rId7" imgW="3056732" imgH="281454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946264" y="1659146"/>
                        <a:ext cx="3057525" cy="2814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95D6957-712C-4FE9-8FC1-CC3BD8AFB631}"/>
              </a:ext>
            </a:extLst>
          </p:cNvPr>
          <p:cNvSpPr txBox="1"/>
          <p:nvPr/>
        </p:nvSpPr>
        <p:spPr>
          <a:xfrm>
            <a:off x="-1055" y="6519446"/>
            <a:ext cx="1188056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7. Narazaciclib induced anti-leukemia effects in a dose-dependent manner in AM7577 PDX model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4A8CC7C-F106-4945-810B-87EACE4494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0501182"/>
              </p:ext>
            </p:extLst>
          </p:nvPr>
        </p:nvGraphicFramePr>
        <p:xfrm>
          <a:off x="297094" y="1497496"/>
          <a:ext cx="2878137" cy="347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48" name="Prism 9" r:id="rId3" imgW="2878554" imgH="3475789" progId="Prism9.Document">
                  <p:embed/>
                </p:oleObj>
              </mc:Choice>
              <mc:Fallback>
                <p:oleObj name="Prism 9" r:id="rId3" imgW="2878554" imgH="347578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7094" y="1497496"/>
                        <a:ext cx="2878137" cy="347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BE41446-BCC1-4736-A04A-F0DED559C8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5999690"/>
              </p:ext>
            </p:extLst>
          </p:nvPr>
        </p:nvGraphicFramePr>
        <p:xfrm>
          <a:off x="3141100" y="1497496"/>
          <a:ext cx="2946400" cy="3490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49" name="Prism 9" r:id="rId5" imgW="2946946" imgH="3491268" progId="Prism9.Document">
                  <p:embed/>
                </p:oleObj>
              </mc:Choice>
              <mc:Fallback>
                <p:oleObj name="Prism 9" r:id="rId5" imgW="2946946" imgH="349126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141100" y="1497496"/>
                        <a:ext cx="2946400" cy="3490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7B7B8D31-A963-4A05-A01B-17FB767722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7205996"/>
              </p:ext>
            </p:extLst>
          </p:nvPr>
        </p:nvGraphicFramePr>
        <p:xfrm>
          <a:off x="6096000" y="1497497"/>
          <a:ext cx="3048000" cy="3544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50" name="Prism 9" r:id="rId7" imgW="3047733" imgH="3544542" progId="Prism9.Document">
                  <p:embed/>
                </p:oleObj>
              </mc:Choice>
              <mc:Fallback>
                <p:oleObj name="Prism 9" r:id="rId7" imgW="3047733" imgH="35445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096000" y="1497497"/>
                        <a:ext cx="3048000" cy="3544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EE59887E-2BDF-4E8B-A9D6-4FFECA95E63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7657253"/>
              </p:ext>
            </p:extLst>
          </p:nvPr>
        </p:nvGraphicFramePr>
        <p:xfrm>
          <a:off x="9059401" y="1497496"/>
          <a:ext cx="2967037" cy="3544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51" name="Prism 9" r:id="rId9" imgW="2966743" imgH="3544542" progId="Prism9.Document">
                  <p:embed/>
                </p:oleObj>
              </mc:Choice>
              <mc:Fallback>
                <p:oleObj name="Prism 9" r:id="rId9" imgW="2966743" imgH="354454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059401" y="1497496"/>
                        <a:ext cx="2967037" cy="3544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C9E4DCBF-EDF3-4528-A6DE-1A36A8946EA6}"/>
              </a:ext>
            </a:extLst>
          </p:cNvPr>
          <p:cNvSpPr txBox="1"/>
          <p:nvPr/>
        </p:nvSpPr>
        <p:spPr>
          <a:xfrm>
            <a:off x="1118188" y="1232857"/>
            <a:ext cx="12359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M809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363F0D7-2F9B-4729-8219-5F658C0BF281}"/>
              </a:ext>
            </a:extLst>
          </p:cNvPr>
          <p:cNvSpPr txBox="1"/>
          <p:nvPr/>
        </p:nvSpPr>
        <p:spPr>
          <a:xfrm>
            <a:off x="4081589" y="1232857"/>
            <a:ext cx="12359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M809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3C19821-A725-490F-95C8-F8273D21E1B6}"/>
              </a:ext>
            </a:extLst>
          </p:cNvPr>
          <p:cNvSpPr txBox="1"/>
          <p:nvPr/>
        </p:nvSpPr>
        <p:spPr>
          <a:xfrm>
            <a:off x="7053490" y="1232857"/>
            <a:ext cx="12359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M757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0A19ECB-303C-4373-B387-D2BEE80B370F}"/>
              </a:ext>
            </a:extLst>
          </p:cNvPr>
          <p:cNvSpPr txBox="1"/>
          <p:nvPr/>
        </p:nvSpPr>
        <p:spPr>
          <a:xfrm>
            <a:off x="10025391" y="1229767"/>
            <a:ext cx="12359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M7577</a:t>
            </a:r>
          </a:p>
        </p:txBody>
      </p:sp>
    </p:spTree>
    <p:extLst>
      <p:ext uri="{BB962C8B-B14F-4D97-AF65-F5344CB8AC3E}">
        <p14:creationId xmlns:p14="http://schemas.microsoft.com/office/powerpoint/2010/main" val="337711352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5E6796E-C661-4A95-90D5-DE73848EA62C}"/>
              </a:ext>
            </a:extLst>
          </p:cNvPr>
          <p:cNvSpPr txBox="1"/>
          <p:nvPr/>
        </p:nvSpPr>
        <p:spPr>
          <a:xfrm>
            <a:off x="0" y="6027003"/>
            <a:ext cx="122169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8. The relationships between responses to narazaciclib and the four putative leukemogenic genes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Left: correlation to the expression of the four putative genes; Right: correlation to the mutation status of FLT3-ITD and KMT2A (MLL). 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73AB3CD-C030-4939-93C1-10AD8E8ED4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28"/>
          <a:stretch/>
        </p:blipFill>
        <p:spPr>
          <a:xfrm>
            <a:off x="24542" y="246222"/>
            <a:ext cx="5764613" cy="5760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06AAF61-0A09-4EAB-83D0-1B5A828D03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05748" y="246221"/>
            <a:ext cx="2713083" cy="4122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1F5DA736-D69C-42C2-95AB-1742D79800E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89155" y="246221"/>
            <a:ext cx="3113601" cy="41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12198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7074242-6789-4E29-8A47-E16CCA31C075}"/>
              </a:ext>
            </a:extLst>
          </p:cNvPr>
          <p:cNvSpPr txBox="1"/>
          <p:nvPr/>
        </p:nvSpPr>
        <p:spPr>
          <a:xfrm>
            <a:off x="0" y="6519446"/>
            <a:ext cx="115638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A. CSF1R median mRNA expression in patient tumor samples and paired normal tissues. 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457A99B-20A3-4D78-89D5-CCCADBFD45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2329562"/>
              </p:ext>
            </p:extLst>
          </p:nvPr>
        </p:nvGraphicFramePr>
        <p:xfrm>
          <a:off x="2408601" y="1269000"/>
          <a:ext cx="7374799" cy="43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24" name="Prism 9" r:id="rId3" imgW="7032427" imgH="4119041" progId="Prism9.Document">
                  <p:embed/>
                </p:oleObj>
              </mc:Choice>
              <mc:Fallback>
                <p:oleObj name="Prism 9" r:id="rId3" imgW="7032427" imgH="411904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08601" y="1269000"/>
                        <a:ext cx="7374799" cy="43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D14D114E-DF8A-40D2-8523-404DD9201FDA}"/>
              </a:ext>
            </a:extLst>
          </p:cNvPr>
          <p:cNvSpPr/>
          <p:nvPr/>
        </p:nvSpPr>
        <p:spPr>
          <a:xfrm>
            <a:off x="5978769" y="1798655"/>
            <a:ext cx="200967" cy="3155182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901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B66624D-1559-4707-8D1D-834599A93F74}"/>
              </a:ext>
            </a:extLst>
          </p:cNvPr>
          <p:cNvSpPr txBox="1"/>
          <p:nvPr/>
        </p:nvSpPr>
        <p:spPr>
          <a:xfrm>
            <a:off x="0" y="6519446"/>
            <a:ext cx="109290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B. FLT-3 median mRNA expression in patient tumor samples and paired normal tissues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1762ED27-5978-412C-8023-3E06CE62DC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949755"/>
              </p:ext>
            </p:extLst>
          </p:nvPr>
        </p:nvGraphicFramePr>
        <p:xfrm>
          <a:off x="2413596" y="1269000"/>
          <a:ext cx="7364808" cy="43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42" name="Prism 9" r:id="rId3" imgW="7023068" imgH="4119041" progId="Prism9.Document">
                  <p:embed/>
                </p:oleObj>
              </mc:Choice>
              <mc:Fallback>
                <p:oleObj name="Prism 9" r:id="rId3" imgW="7023068" imgH="411904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13596" y="1269000"/>
                        <a:ext cx="7364808" cy="43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2B69CA06-02B4-42D9-8EC7-F21A565E625C}"/>
              </a:ext>
            </a:extLst>
          </p:cNvPr>
          <p:cNvSpPr/>
          <p:nvPr/>
        </p:nvSpPr>
        <p:spPr>
          <a:xfrm>
            <a:off x="5960348" y="1678075"/>
            <a:ext cx="259582" cy="3275762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3069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2D13E82-8E75-4399-B6A0-CF0E59A49CBC}"/>
              </a:ext>
            </a:extLst>
          </p:cNvPr>
          <p:cNvSpPr txBox="1"/>
          <p:nvPr/>
        </p:nvSpPr>
        <p:spPr>
          <a:xfrm>
            <a:off x="0" y="6519446"/>
            <a:ext cx="108974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C. MLL median mRNA expression in patient tumor samples and paired normal tissues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9022E4F-C7DB-49DA-8735-9C75D907E8F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8618174"/>
              </p:ext>
            </p:extLst>
          </p:nvPr>
        </p:nvGraphicFramePr>
        <p:xfrm>
          <a:off x="2409434" y="1269000"/>
          <a:ext cx="7373132" cy="43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63" name="Prism 9" r:id="rId3" imgW="7030987" imgH="4119041" progId="Prism9.Document">
                  <p:embed/>
                </p:oleObj>
              </mc:Choice>
              <mc:Fallback>
                <p:oleObj name="Prism 9" r:id="rId3" imgW="7030987" imgH="411904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09434" y="1269000"/>
                        <a:ext cx="7373132" cy="43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4415EDA9-0A0B-4220-958F-37F9ABBE85DB}"/>
              </a:ext>
            </a:extLst>
          </p:cNvPr>
          <p:cNvSpPr/>
          <p:nvPr/>
        </p:nvSpPr>
        <p:spPr>
          <a:xfrm>
            <a:off x="5990491" y="1798655"/>
            <a:ext cx="209341" cy="3155182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6034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3DBA850-79F5-429A-A47A-2049625DE604}"/>
              </a:ext>
            </a:extLst>
          </p:cNvPr>
          <p:cNvSpPr txBox="1"/>
          <p:nvPr/>
        </p:nvSpPr>
        <p:spPr>
          <a:xfrm>
            <a:off x="0" y="6519446"/>
            <a:ext cx="110117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D. CDK6 median mRNA expression in patient tumor samples and paired normal tissues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C4AE679-31C7-461E-B88C-279A8A5580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6462718"/>
              </p:ext>
            </p:extLst>
          </p:nvPr>
        </p:nvGraphicFramePr>
        <p:xfrm>
          <a:off x="2409434" y="1269000"/>
          <a:ext cx="7373132" cy="43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8" name="Prism 9" r:id="rId3" imgW="7030987" imgH="4119041" progId="Prism9.Document">
                  <p:embed/>
                </p:oleObj>
              </mc:Choice>
              <mc:Fallback>
                <p:oleObj name="Prism 9" r:id="rId3" imgW="7030987" imgH="411904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09434" y="1269000"/>
                        <a:ext cx="7373132" cy="43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4428D3A8-64B1-42F0-90E8-5343AFFFF7B7}"/>
              </a:ext>
            </a:extLst>
          </p:cNvPr>
          <p:cNvSpPr/>
          <p:nvPr/>
        </p:nvSpPr>
        <p:spPr>
          <a:xfrm>
            <a:off x="5991329" y="1678075"/>
            <a:ext cx="208503" cy="3255666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7703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5D0FCA0-8B8A-4F44-8751-91DAE2F8B3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5299668"/>
              </p:ext>
            </p:extLst>
          </p:nvPr>
        </p:nvGraphicFramePr>
        <p:xfrm>
          <a:off x="2409434" y="1269000"/>
          <a:ext cx="7373132" cy="43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86" name="Prism 9" r:id="rId3" imgW="7030987" imgH="4119041" progId="Prism9.Document">
                  <p:embed/>
                </p:oleObj>
              </mc:Choice>
              <mc:Fallback>
                <p:oleObj name="Prism 9" r:id="rId3" imgW="7030987" imgH="411904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09434" y="1269000"/>
                        <a:ext cx="7373132" cy="43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2C2892D-C22C-48C3-B2B9-CFA70427D8AE}"/>
              </a:ext>
            </a:extLst>
          </p:cNvPr>
          <p:cNvSpPr txBox="1"/>
          <p:nvPr/>
        </p:nvSpPr>
        <p:spPr>
          <a:xfrm>
            <a:off x="0" y="6519446"/>
            <a:ext cx="108979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. SIK3 median mRNA expression in patient tumor samples and paired normal tissue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5717BA8-EB2F-41F6-AFF7-2B8BAD1113B8}"/>
              </a:ext>
            </a:extLst>
          </p:cNvPr>
          <p:cNvSpPr/>
          <p:nvPr/>
        </p:nvSpPr>
        <p:spPr>
          <a:xfrm>
            <a:off x="6000540" y="1798655"/>
            <a:ext cx="189244" cy="3155182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3011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6110477-4533-4774-934A-A5A145256C70}"/>
              </a:ext>
            </a:extLst>
          </p:cNvPr>
          <p:cNvSpPr txBox="1"/>
          <p:nvPr/>
        </p:nvSpPr>
        <p:spPr>
          <a:xfrm>
            <a:off x="0" y="6519446"/>
            <a:ext cx="112518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F. MEF2C median mRNA expression in patient tumor samples and paired normal tissues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D0FE55B-944A-46AD-8F37-B2CF0D4B58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4937904"/>
              </p:ext>
            </p:extLst>
          </p:nvPr>
        </p:nvGraphicFramePr>
        <p:xfrm>
          <a:off x="2409434" y="1269000"/>
          <a:ext cx="7373132" cy="43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10" name="Prism 9" r:id="rId3" imgW="7030987" imgH="4119041" progId="Prism9.Document">
                  <p:embed/>
                </p:oleObj>
              </mc:Choice>
              <mc:Fallback>
                <p:oleObj name="Prism 9" r:id="rId3" imgW="7030987" imgH="411904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09434" y="1269000"/>
                        <a:ext cx="7373132" cy="43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228B5215-2ABF-481A-A472-3FFFAA9DCEF8}"/>
              </a:ext>
            </a:extLst>
          </p:cNvPr>
          <p:cNvSpPr/>
          <p:nvPr/>
        </p:nvSpPr>
        <p:spPr>
          <a:xfrm>
            <a:off x="5990491" y="1678075"/>
            <a:ext cx="209341" cy="3275762"/>
          </a:xfrm>
          <a:prstGeom prst="rect">
            <a:avLst/>
          </a:prstGeom>
          <a:noFill/>
          <a:ln w="28575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1587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362BA2-0368-421E-94CB-918A8B4B7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339" y="5901004"/>
            <a:ext cx="11986117" cy="956996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G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-regulations among the four putative leukemogenic genes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Pairwise correlation for 4 genes across 173 LAML patients from TCGA were analyzed. The results showed positive correlations between CDK6 and MLL; between CDK6 and FLT3 expression; to less degree between FLT3 and MLL; negative correlation between CSF1R and CDK6 expressions; no correlation between CSF1R and FLT3, between CSF1R and MLL expression. </a:t>
            </a:r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values: *: p &lt; 0.05; **: 0.01 &lt; p &lt; 0.05; ***: p &lt; 0.001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29C6606-CA7A-4071-8CE3-84324DBC3B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7255" y="0"/>
            <a:ext cx="7884204" cy="586949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975C551-DFB0-4C29-9739-656621A929DA}"/>
              </a:ext>
            </a:extLst>
          </p:cNvPr>
          <p:cNvSpPr txBox="1"/>
          <p:nvPr/>
        </p:nvSpPr>
        <p:spPr>
          <a:xfrm>
            <a:off x="2230541" y="181744"/>
            <a:ext cx="638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SF1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28D936D-210B-4D50-90A5-EFD59DEBF639}"/>
              </a:ext>
            </a:extLst>
          </p:cNvPr>
          <p:cNvSpPr txBox="1"/>
          <p:nvPr/>
        </p:nvSpPr>
        <p:spPr>
          <a:xfrm>
            <a:off x="4171985" y="1556183"/>
            <a:ext cx="5081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FLT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A84699C-066A-4DEF-AA6A-F4747E517A56}"/>
              </a:ext>
            </a:extLst>
          </p:cNvPr>
          <p:cNvSpPr txBox="1"/>
          <p:nvPr/>
        </p:nvSpPr>
        <p:spPr>
          <a:xfrm>
            <a:off x="6012493" y="2934745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DK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CD46F20-0017-43AA-B9A2-96AC00E58D06}"/>
              </a:ext>
            </a:extLst>
          </p:cNvPr>
          <p:cNvSpPr txBox="1"/>
          <p:nvPr/>
        </p:nvSpPr>
        <p:spPr>
          <a:xfrm>
            <a:off x="7822959" y="431074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MLL</a:t>
            </a:r>
          </a:p>
        </p:txBody>
      </p:sp>
    </p:spTree>
    <p:extLst>
      <p:ext uri="{BB962C8B-B14F-4D97-AF65-F5344CB8AC3E}">
        <p14:creationId xmlns:p14="http://schemas.microsoft.com/office/powerpoint/2010/main" val="21061137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6273225"/>
            <a:ext cx="119474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. Growth kinetics and/or SOC treatments of two new AML-PDXs. A. AM8096; B. AM5512.</a:t>
            </a:r>
            <a:r>
              <a: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  <a:r>
              <a:rPr lang="zh-CN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growth is represented as percentage of human CD45 positive leukocytes in peripheral blood.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24AD829-E1DD-4573-9FE5-4D3C0502DE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9182092"/>
              </p:ext>
            </p:extLst>
          </p:nvPr>
        </p:nvGraphicFramePr>
        <p:xfrm>
          <a:off x="1819064" y="1100050"/>
          <a:ext cx="3925478" cy="32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0" name="Prism 9" r:id="rId3" imgW="3791398" imgH="3128426" progId="Prism9.Document">
                  <p:embed/>
                </p:oleObj>
              </mc:Choice>
              <mc:Fallback>
                <p:oleObj name="Prism 9" r:id="rId3" imgW="3791398" imgH="312842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19064" y="1100050"/>
                        <a:ext cx="3925478" cy="324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A109AF83-6812-46AA-A2C1-E7720B38AD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3037209"/>
              </p:ext>
            </p:extLst>
          </p:nvPr>
        </p:nvGraphicFramePr>
        <p:xfrm>
          <a:off x="6255971" y="1100050"/>
          <a:ext cx="4020377" cy="302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1" name="Prism 9" r:id="rId5" imgW="3842872" imgH="2890852" progId="Prism9.Document">
                  <p:embed/>
                </p:oleObj>
              </mc:Choice>
              <mc:Fallback>
                <p:oleObj name="Prism 9" r:id="rId5" imgW="3842872" imgH="289085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55971" y="1100050"/>
                        <a:ext cx="4020377" cy="302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60817BFD-54F8-42F6-84E1-EA2E39A66022}"/>
              </a:ext>
            </a:extLst>
          </p:cNvPr>
          <p:cNvSpPr txBox="1"/>
          <p:nvPr/>
        </p:nvSpPr>
        <p:spPr>
          <a:xfrm>
            <a:off x="1819064" y="928244"/>
            <a:ext cx="381837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C024168-194C-45EE-A2A9-ED49ADCD1105}"/>
              </a:ext>
            </a:extLst>
          </p:cNvPr>
          <p:cNvSpPr txBox="1"/>
          <p:nvPr/>
        </p:nvSpPr>
        <p:spPr>
          <a:xfrm>
            <a:off x="6255971" y="928244"/>
            <a:ext cx="381837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09</TotalTime>
  <Words>436</Words>
  <Application>Microsoft Office PowerPoint</Application>
  <PresentationFormat>Widescreen</PresentationFormat>
  <Paragraphs>45</Paragraphs>
  <Slides>1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2" baseType="lpstr">
      <vt:lpstr>等线</vt:lpstr>
      <vt:lpstr>等线 Light</vt:lpstr>
      <vt:lpstr>Arial</vt:lpstr>
      <vt:lpstr>Calibri</vt:lpstr>
      <vt:lpstr>Calibri Light</vt:lpstr>
      <vt:lpstr>Office Theme</vt:lpstr>
      <vt:lpstr>Prism 9</vt:lpstr>
      <vt:lpstr>Supplemental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al Figure 1G. Co-regulations among the four putative leukemogenic genes. Pairwise correlation for 4 genes across 173 LAML patients from TCGA were analyzed. The results showed positive correlations between CDK6 and MLL; between CDK6 and FLT3 expression; to less degree between FLT3 and MLL; negative correlation between CSF1R and CDK6 expressions; no correlation between CSF1R and FLT3, between CSF1R and MLL expression. p-values: *: p &lt; 0.05; **: 0.01 &lt; p &lt; 0.05; ***: p &lt; 0.001.</vt:lpstr>
      <vt:lpstr>PowerPoint Presentation</vt:lpstr>
      <vt:lpstr>PowerPoint Presentation</vt:lpstr>
      <vt:lpstr>PowerPoint Presentation</vt:lpstr>
      <vt:lpstr>Supplemental Figure S5. Growth inhibition readouts AUC vs. IC50. A: Definitions of AUC and IC50 of proliferation inhibition. B: Extremely high concordance (positive correlation) between AUC and IC50 across 33 AML cell lines.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henry</dc:creator>
  <cp:lastModifiedBy>henry</cp:lastModifiedBy>
  <cp:revision>264</cp:revision>
  <dcterms:created xsi:type="dcterms:W3CDTF">2022-07-24T07:04:00Z</dcterms:created>
  <dcterms:modified xsi:type="dcterms:W3CDTF">2024-02-17T08:26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208</vt:lpwstr>
  </property>
</Properties>
</file>